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DDAA2-33CE-44AA-9BC7-13E3F47D8B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8A1204-E17C-4F69-AC42-46AD5593C9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6AE63-7293-4F37-8F78-FED5EB4BF2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70CE93-B900-4811-B48A-6416045783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8B5792-78D7-440A-86C0-93210C44E8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EB2E64-88AB-4C32-9926-3B4B3B97E2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BFE0D-0803-4EB5-B528-8F6A8CA4D1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6E8DC-7DA9-4301-B8D0-D8CF16A23F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B1BB9-FA34-43FE-A256-601B4C5E4E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C73F5-194B-448A-A7F8-3A1243FE59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177DED-C091-4ACB-90B8-F0C4FA0409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7938E7-2B5B-4DDE-9B8A-8212899F23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A3A95D-4C50-4982-A23F-D0B352EC2340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B58DAE-8E16-4153-9A12-1506C59E88BD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65"/>
          <p:cNvSpPr/>
          <p:nvPr/>
        </p:nvSpPr>
        <p:spPr>
          <a:xfrm>
            <a:off x="1860480" y="1631880"/>
            <a:ext cx="49449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2  </a:t>
            </a: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  Long-range PCR reaction system (50 </a:t>
            </a:r>
            <a:r>
              <a:rPr b="0" lang="zh-CN" sz="13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L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23"/>
          <p:cNvSpPr/>
          <p:nvPr/>
        </p:nvSpPr>
        <p:spPr>
          <a:xfrm>
            <a:off x="1488960" y="518004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直线连接符 24"/>
          <p:cNvSpPr/>
          <p:nvPr/>
        </p:nvSpPr>
        <p:spPr>
          <a:xfrm>
            <a:off x="1488960" y="201456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17"/>
          <p:cNvSpPr/>
          <p:nvPr/>
        </p:nvSpPr>
        <p:spPr>
          <a:xfrm>
            <a:off x="3946680" y="2092320"/>
            <a:ext cx="12380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Volume (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18"/>
          <p:cNvSpPr/>
          <p:nvPr/>
        </p:nvSpPr>
        <p:spPr>
          <a:xfrm>
            <a:off x="1488960" y="2602800"/>
            <a:ext cx="2159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2× KOD FX Neo Buffer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矩形 19"/>
          <p:cNvSpPr/>
          <p:nvPr/>
        </p:nvSpPr>
        <p:spPr>
          <a:xfrm>
            <a:off x="5560920" y="2076480"/>
            <a:ext cx="16210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Final concent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20"/>
          <p:cNvSpPr/>
          <p:nvPr/>
        </p:nvSpPr>
        <p:spPr>
          <a:xfrm>
            <a:off x="1746360" y="2122560"/>
            <a:ext cx="10206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Componen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25"/>
          <p:cNvSpPr/>
          <p:nvPr/>
        </p:nvSpPr>
        <p:spPr>
          <a:xfrm>
            <a:off x="1488960" y="2978280"/>
            <a:ext cx="2159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dNTPs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（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2mM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）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26"/>
          <p:cNvSpPr/>
          <p:nvPr/>
        </p:nvSpPr>
        <p:spPr>
          <a:xfrm>
            <a:off x="1488960" y="3353760"/>
            <a:ext cx="2159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Forward primer (10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27"/>
          <p:cNvSpPr/>
          <p:nvPr/>
        </p:nvSpPr>
        <p:spPr>
          <a:xfrm>
            <a:off x="1488960" y="3728160"/>
            <a:ext cx="2159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Reverse primer (10 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28"/>
          <p:cNvSpPr/>
          <p:nvPr/>
        </p:nvSpPr>
        <p:spPr>
          <a:xfrm>
            <a:off x="5560920" y="2602800"/>
            <a:ext cx="14400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1X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29"/>
          <p:cNvSpPr/>
          <p:nvPr/>
        </p:nvSpPr>
        <p:spPr>
          <a:xfrm>
            <a:off x="5560920" y="3405960"/>
            <a:ext cx="14400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0.3 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32"/>
          <p:cNvSpPr/>
          <p:nvPr/>
        </p:nvSpPr>
        <p:spPr>
          <a:xfrm>
            <a:off x="5560920" y="3664440"/>
            <a:ext cx="144000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0.3 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本框 33"/>
          <p:cNvSpPr/>
          <p:nvPr/>
        </p:nvSpPr>
        <p:spPr>
          <a:xfrm>
            <a:off x="5533920" y="4097520"/>
            <a:ext cx="1440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1U/50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本框 34"/>
          <p:cNvSpPr/>
          <p:nvPr/>
        </p:nvSpPr>
        <p:spPr>
          <a:xfrm>
            <a:off x="3971880" y="259884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2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本框 35"/>
          <p:cNvSpPr/>
          <p:nvPr/>
        </p:nvSpPr>
        <p:spPr>
          <a:xfrm>
            <a:off x="3971880" y="2976480"/>
            <a:ext cx="72072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10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本框 36"/>
          <p:cNvSpPr/>
          <p:nvPr/>
        </p:nvSpPr>
        <p:spPr>
          <a:xfrm>
            <a:off x="3971880" y="335448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1.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37"/>
          <p:cNvSpPr/>
          <p:nvPr/>
        </p:nvSpPr>
        <p:spPr>
          <a:xfrm>
            <a:off x="3971880" y="373068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1.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38"/>
          <p:cNvSpPr/>
          <p:nvPr/>
        </p:nvSpPr>
        <p:spPr>
          <a:xfrm>
            <a:off x="1455840" y="5237280"/>
            <a:ext cx="626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Note: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NTPs were supplied at 2 mM each. Nuclease-free water was used to bring the total volume to 50 μL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直线连接符 1"/>
          <p:cNvSpPr/>
          <p:nvPr/>
        </p:nvSpPr>
        <p:spPr>
          <a:xfrm>
            <a:off x="1488960" y="246708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本框 40"/>
          <p:cNvSpPr/>
          <p:nvPr/>
        </p:nvSpPr>
        <p:spPr>
          <a:xfrm>
            <a:off x="1488960" y="4104360"/>
            <a:ext cx="2159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KOD FX Neo(1U/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41"/>
          <p:cNvSpPr/>
          <p:nvPr/>
        </p:nvSpPr>
        <p:spPr>
          <a:xfrm>
            <a:off x="3971880" y="410832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1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本框 42"/>
          <p:cNvSpPr/>
          <p:nvPr/>
        </p:nvSpPr>
        <p:spPr>
          <a:xfrm>
            <a:off x="1488960" y="4479120"/>
            <a:ext cx="2159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Genomic DN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文本框 43"/>
          <p:cNvSpPr/>
          <p:nvPr/>
        </p:nvSpPr>
        <p:spPr>
          <a:xfrm>
            <a:off x="1539720" y="4893480"/>
            <a:ext cx="2159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ddH₂O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文本框 44"/>
          <p:cNvSpPr/>
          <p:nvPr/>
        </p:nvSpPr>
        <p:spPr>
          <a:xfrm>
            <a:off x="3971880" y="486396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to 50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本框 45"/>
          <p:cNvSpPr/>
          <p:nvPr/>
        </p:nvSpPr>
        <p:spPr>
          <a:xfrm>
            <a:off x="3971880" y="448632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 baseline="30000">
                <a:solidFill>
                  <a:srgbClr val="000000"/>
                </a:solidFill>
                <a:latin typeface="Times New Roman"/>
                <a:ea typeface="微软雅黑"/>
              </a:rPr>
              <a:t>___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本框 46"/>
          <p:cNvSpPr/>
          <p:nvPr/>
        </p:nvSpPr>
        <p:spPr>
          <a:xfrm>
            <a:off x="5560920" y="4448520"/>
            <a:ext cx="1440000" cy="47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~100ng/50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本框 47"/>
          <p:cNvSpPr/>
          <p:nvPr/>
        </p:nvSpPr>
        <p:spPr>
          <a:xfrm>
            <a:off x="5560920" y="4855680"/>
            <a:ext cx="14400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 baseline="30000">
                <a:solidFill>
                  <a:srgbClr val="000000"/>
                </a:solidFill>
                <a:latin typeface="Times New Roman"/>
                <a:ea typeface="微软雅黑"/>
              </a:rPr>
              <a:t>_______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本框 48"/>
          <p:cNvSpPr/>
          <p:nvPr/>
        </p:nvSpPr>
        <p:spPr>
          <a:xfrm>
            <a:off x="5381640" y="2887560"/>
            <a:ext cx="1800360" cy="46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0.4 mM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4:12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